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41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8F10ED-39C4-4E1D-A104-C898351427A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10278E9D-26A1-413D-9670-9CA7D6265B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1C4E552-20EF-4F7B-A285-9A6B702C1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0C84D4F-F445-4F8A-A34A-F89B5D6E64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E9CA631-D568-40F8-8EA8-B890CF97D1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769044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9E904D6-C9E2-46B1-B885-43AAB832CE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1A9DA77B-B7B7-4AED-B11A-72F3496FF4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D8C4CA6-6EDC-40E3-8C95-59A5BCFB02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FFEB4F3-8FE0-4239-9EE0-7A18967EA5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ABEBB69-A654-498A-B2E7-88E9BF8D59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182078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ACAE7A23-34F8-4E91-9839-CE2FD0832D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64A45C49-9F12-4665-8313-096D65C12A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29AC416-2B82-4A47-ADF7-2009C90DA2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7467CB8-CB13-4B33-8917-A1552835D8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4465247-10F6-4611-BB42-A4C35AF89F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218994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3E024C1-08B2-4B17-8F20-3F17CDA68E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EFB9180-2E26-4390-B9CB-8762401AE4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B7F9B36-43DE-4ADF-8A8D-1CA3655C5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6730E5F-96A4-415E-AAB9-AAB10881F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F5E1B2C-3837-448E-AD7B-AE985400F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33375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26DFC1F-40EA-40C6-960D-8ED2892466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9F3E95BB-2C54-443C-B47C-6E0F0B1895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215A657-0897-43F8-BE17-C918DD5DBF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4C3D629-F266-48E8-A4EB-87D7CDBC4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E865F8A-CFFA-4103-8865-7C37B2995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78181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54CDC6D-8264-4004-873A-45914559BA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8209C35A-FAD9-4F68-8864-8621FF2C06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093E925-7440-4D65-8F8E-9F3B857BB3F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9996987-CDE0-4AB2-B2F3-BB5D83B06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9069035-798D-443A-9EBD-75D286655C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6054CCF-46D6-4894-8921-83EEDC432F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9875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16A1EF-FADE-40D2-A0DC-28761B86BD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284C8F5-2A50-488A-96D0-29A68652DA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2C12642-27AA-479D-B185-0B129AECBA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088E30A-7EEC-4AD1-B58F-6C5AE4A181C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E0C3C170-7559-4143-9A85-7820135B665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649D88D8-8937-4887-86CF-51BEA6883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A5C4ECCA-7606-405D-9F68-71583C3FAD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EA576CF-3974-42D5-A28B-F2E5A927B9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06037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3CC6929-0F9D-4945-BD3C-68A93F569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586D0D5-478F-457A-8005-A2AA6E874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2826375E-B577-4A57-B3D3-1799778DBF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100705E8-545B-4260-B73D-04FA747A71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70911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F764122-78C6-4546-BF87-52CA19465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DFDC7C9-FC6B-43FB-BF08-3B61E1977F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FB6ADB9-261A-4511-A1D8-C1CEAD217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8296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F1F3105-2BC8-4D70-896E-65CF46247D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54BC2BE-07DB-4962-805E-A699A0A0C34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452F6B5-2269-4801-9751-5EF44B3BA2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03B8854E-5421-423E-9057-72AD3137AF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4740884-6D04-4D7A-AF2E-CFBAD1F67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DA9A1A3-05B4-474C-920D-762290045E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64475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E67784-3A96-49E8-9CA3-9C57106F85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31B5CC3D-F1DC-4DAE-A0DA-71EF1FC370D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2C0FC57F-A518-4494-8C0F-1531CDBB21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686550E-6A0B-4454-BF28-5988CC31C1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5FFEF43-73D2-441B-8BB2-6F285BC30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8FDE967-945A-4A80-9319-A728EED8A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10260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65C5B8FD-A327-4783-B5A0-4443F129E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3108E30-8979-4D14-BB03-B35DDD6010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398593A-4B44-4AD4-B0D8-305D413B4E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CAD86-6828-4720-9F47-F7D9EC305C75}" type="datetimeFigureOut">
              <a:rPr lang="it-IT" smtClean="0"/>
              <a:t>13/09/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3A23B6C-43E6-4C15-8790-B5AB51B3F9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9EBA3EF-2209-4AC5-BBBF-6DFFFAEE612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8A157-15DD-4EC7-9818-822E760F013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7723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8DD1B8F9-EA92-4565-B4C9-179DBC2612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it-IT"/>
          </a:p>
        </p:txBody>
      </p:sp>
      <p:pic>
        <p:nvPicPr>
          <p:cNvPr id="1025" name="Immagine 5">
            <a:extLst>
              <a:ext uri="{FF2B5EF4-FFF2-40B4-BE49-F238E27FC236}">
                <a16:creationId xmlns:a16="http://schemas.microsoft.com/office/drawing/2014/main" id="{633FD0C7-DADA-4885-A210-FECC9A17147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845" y="1082842"/>
            <a:ext cx="9389071" cy="40364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DC10A45B-0BE8-4429-A6F3-8AC55B7AAFC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4845" y="5347865"/>
            <a:ext cx="10142622" cy="5232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it-IT" sz="14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</a:t>
            </a:r>
            <a:r>
              <a:rPr kumimoji="0" lang="en-US" altLang="it-IT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emperature variation observed in Acerra during the summer 2019. Daily maximum (red), daily mean (blue) temperatures. Dashed </a:t>
            </a:r>
            <a:r>
              <a:rPr kumimoji="0" lang="en-US" altLang="it-IT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d line </a:t>
            </a:r>
            <a:r>
              <a:rPr lang="en-US" altLang="it-IT" sz="14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s </a:t>
            </a:r>
            <a:r>
              <a:rPr kumimoji="0" lang="en-US" altLang="it-IT" sz="1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critical threshold of 32 </a:t>
            </a:r>
            <a:r>
              <a:rPr kumimoji="0" lang="en-US" altLang="it-IT" sz="1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°C.</a:t>
            </a:r>
            <a:endParaRPr kumimoji="0" lang="en-US" altLang="it-IT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369679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ABRIZIO OLIVIERI</dc:creator>
  <cp:lastModifiedBy>Microsoft Office User</cp:lastModifiedBy>
  <cp:revision>7</cp:revision>
  <dcterms:created xsi:type="dcterms:W3CDTF">2021-05-12T10:00:21Z</dcterms:created>
  <dcterms:modified xsi:type="dcterms:W3CDTF">2021-09-13T10:02:24Z</dcterms:modified>
</cp:coreProperties>
</file>